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3200" cy="993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804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8E0047-2B85-424D-95AC-4A766745874D}" type="datetime">
              <a:rPr b="0" lang="ja-JP" sz="1200" spc="-1" strike="noStrike">
                <a:solidFill>
                  <a:srgbClr val="000000"/>
                </a:solidFill>
                <a:latin typeface="Arial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8160" y="744120"/>
            <a:ext cx="2578320" cy="3724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D2FBE4-57ED-4EB7-AE0E-47D806503B36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2108160" y="744480"/>
            <a:ext cx="2578320" cy="372420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スライド番号プレースホルダー 3"/>
          <p:cNvSpPr/>
          <p:nvPr/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05FDC9-396D-4BC7-A44B-8A8504C3FB80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C7F848-AC68-4300-81FA-E969BFE3BF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7905B-066D-48DF-8760-C4317BB450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7EBD76-EC49-43FF-AE0C-B48F06D5D3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BF09C5-9FAF-4943-8C2F-360448DB462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06A060-80FA-42DB-9D33-334753487B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0D60AF-2520-45D2-BFE1-B02ADB2A60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37A600-E095-402F-93EB-9464AAE442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F8D164-C4CC-409A-A8B0-DEF07A6B59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A812A2-C0E6-4980-A503-B29CBE88B6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563192-D8F1-48BA-929C-0AEF653AA1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BEDCA6-816F-4179-AE56-3E861524FC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7587C6-449A-4390-A1B7-3DA98F9937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AC03AF-E035-449B-9796-79A1269D6C4B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9FECC1-2027-4497-A644-812737FFDC05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56"/>
          <p:cNvSpPr/>
          <p:nvPr/>
        </p:nvSpPr>
        <p:spPr>
          <a:xfrm rot="16200000">
            <a:off x="-202680" y="1839240"/>
            <a:ext cx="1292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iability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グラフ 94" descr=""/>
          <p:cNvPicPr/>
          <p:nvPr/>
        </p:nvPicPr>
        <p:blipFill>
          <a:blip r:embed="rId1"/>
          <a:stretch/>
        </p:blipFill>
        <p:spPr>
          <a:xfrm>
            <a:off x="817560" y="1152360"/>
            <a:ext cx="1371600" cy="2060640"/>
          </a:xfrm>
          <a:prstGeom prst="rect">
            <a:avLst/>
          </a:prstGeom>
          <a:ln w="0">
            <a:noFill/>
          </a:ln>
        </p:spPr>
      </p:pic>
      <p:sp>
        <p:nvSpPr>
          <p:cNvPr id="50" name="TextBox 12"/>
          <p:cNvSpPr/>
          <p:nvPr/>
        </p:nvSpPr>
        <p:spPr>
          <a:xfrm>
            <a:off x="570240" y="17226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2"/>
          <p:cNvSpPr/>
          <p:nvPr/>
        </p:nvSpPr>
        <p:spPr>
          <a:xfrm>
            <a:off x="570240" y="26478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2"/>
          <p:cNvSpPr/>
          <p:nvPr/>
        </p:nvSpPr>
        <p:spPr>
          <a:xfrm>
            <a:off x="570240" y="23302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2"/>
          <p:cNvSpPr/>
          <p:nvPr/>
        </p:nvSpPr>
        <p:spPr>
          <a:xfrm>
            <a:off x="569520" y="20257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23"/>
          <p:cNvSpPr/>
          <p:nvPr/>
        </p:nvSpPr>
        <p:spPr>
          <a:xfrm>
            <a:off x="636480" y="29541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2"/>
          <p:cNvSpPr/>
          <p:nvPr/>
        </p:nvSpPr>
        <p:spPr>
          <a:xfrm>
            <a:off x="486360" y="141912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2"/>
          <p:cNvSpPr/>
          <p:nvPr/>
        </p:nvSpPr>
        <p:spPr>
          <a:xfrm>
            <a:off x="491040" y="11066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23"/>
          <p:cNvSpPr/>
          <p:nvPr/>
        </p:nvSpPr>
        <p:spPr>
          <a:xfrm>
            <a:off x="1011240" y="3059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23"/>
          <p:cNvSpPr/>
          <p:nvPr/>
        </p:nvSpPr>
        <p:spPr>
          <a:xfrm>
            <a:off x="1569960" y="3059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4"/>
          <p:cNvSpPr/>
          <p:nvPr/>
        </p:nvSpPr>
        <p:spPr>
          <a:xfrm>
            <a:off x="533520" y="3392640"/>
            <a:ext cx="60195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1. No apparent cytotoxicity of rVpr.  HuH-7 cells were treated for 2 days with 5 ng/mL of rVpr and cultured for 10 days. Then, colonies were stained by methylene blue, and numbers of colonies were counted. Lane 1, buffer; lane 2, rVp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3"/>
          <p:cNvSpPr/>
          <p:nvPr/>
        </p:nvSpPr>
        <p:spPr>
          <a:xfrm>
            <a:off x="304920" y="457200"/>
            <a:ext cx="3024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2T00:59:02Z</dcterms:created>
  <dc:creator>奥平准之</dc:creator>
  <dc:description/>
  <dc:language>en-US</dc:language>
  <cp:lastModifiedBy>Santos, Noribeth</cp:lastModifiedBy>
  <cp:lastPrinted>2013-06-12T04:06:08Z</cp:lastPrinted>
  <dcterms:modified xsi:type="dcterms:W3CDTF">2013-06-14T07:43:55Z</dcterms:modified>
  <cp:revision>1632</cp:revision>
  <dc:subject/>
  <dc:title>スライド 1</dc:title>
</cp:coreProperties>
</file>